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9" d="100"/>
          <a:sy n="99" d="100"/>
        </p:scale>
        <p:origin x="90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6471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0354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9686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231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6697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2920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94056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2931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4449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4350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1969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553083-1750-46C2-BF5F-4CF83069EBB3}" type="datetimeFigureOut">
              <a:rPr lang="zh-CN" altLang="en-US" smtClean="0"/>
              <a:t>2019/12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D28FF-B242-4596-B372-29FA711CC4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648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EDA524C-3EFE-4AF6-9E0A-8706BAB1E9F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28" t="18137" r="16528" b="36317"/>
          <a:stretch/>
        </p:blipFill>
        <p:spPr>
          <a:xfrm>
            <a:off x="2739751" y="798493"/>
            <a:ext cx="3664498" cy="191251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C12F325-31F9-401F-A198-9FE090C0885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61" t="27705" r="12896" b="26750"/>
          <a:stretch/>
        </p:blipFill>
        <p:spPr>
          <a:xfrm>
            <a:off x="2749177" y="2942825"/>
            <a:ext cx="3664498" cy="1912512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89BB0A91-AB4D-41CC-A7C3-4088F127B1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15780" y="90155"/>
            <a:ext cx="3334637" cy="708338"/>
          </a:xfrm>
          <a:prstGeom prst="rect">
            <a:avLst/>
          </a:prstGeom>
        </p:spPr>
      </p:pic>
      <p:sp>
        <p:nvSpPr>
          <p:cNvPr id="11" name="矩形 10">
            <a:extLst>
              <a:ext uri="{FF2B5EF4-FFF2-40B4-BE49-F238E27FC236}">
                <a16:creationId xmlns:a16="http://schemas.microsoft.com/office/drawing/2014/main" id="{57DED704-A43B-454F-B4A8-B1C0D6FBD725}"/>
              </a:ext>
            </a:extLst>
          </p:cNvPr>
          <p:cNvSpPr/>
          <p:nvPr/>
        </p:nvSpPr>
        <p:spPr>
          <a:xfrm>
            <a:off x="6404249" y="3445730"/>
            <a:ext cx="9076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dirty="0">
                <a:latin typeface="TimesNewRomanPSMT"/>
              </a:rPr>
              <a:t>α-</a:t>
            </a:r>
            <a:r>
              <a:rPr lang="en-US" altLang="zh-CN" dirty="0">
                <a:latin typeface="TimesNewRomanPSMT"/>
              </a:rPr>
              <a:t>MYC</a:t>
            </a:r>
            <a:endParaRPr lang="zh-CN" altLang="en-US" dirty="0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83A80531-5329-4A52-8B3D-344E30E00609}"/>
              </a:ext>
            </a:extLst>
          </p:cNvPr>
          <p:cNvSpPr/>
          <p:nvPr/>
        </p:nvSpPr>
        <p:spPr>
          <a:xfrm>
            <a:off x="6325705" y="1416050"/>
            <a:ext cx="8050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dirty="0">
                <a:latin typeface="TimesNewRomanPSMT"/>
              </a:rPr>
              <a:t>α-</a:t>
            </a:r>
            <a:r>
              <a:rPr lang="en-US" altLang="zh-CN" dirty="0">
                <a:latin typeface="TimesNewRomanPSMT"/>
              </a:rPr>
              <a:t>GFP</a:t>
            </a:r>
            <a:endParaRPr lang="zh-CN" altLang="en-US" dirty="0"/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8B32F2D6-B2CA-4834-AA2B-920F5F4F4417}"/>
              </a:ext>
            </a:extLst>
          </p:cNvPr>
          <p:cNvSpPr/>
          <p:nvPr/>
        </p:nvSpPr>
        <p:spPr>
          <a:xfrm>
            <a:off x="1281136" y="4937906"/>
            <a:ext cx="691163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urce data for Fig. 5b</a:t>
            </a:r>
          </a:p>
          <a:p>
            <a:r>
              <a:rPr lang="en-GB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immunoprecipitation assays of OsTb1 and OsTb2. Protein extracts from rice protoplasts harbouring MYC-OsTb1 and GFP-OsTb2 were coimmunoprecipitated by anti-GFP beads and detected by anti-GFP and anti-MYC antibodies. Protoplasts transformed with single MYC-OsTb1 or GFP-OsTb2 were used as a negative control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6794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52</Words>
  <Application>Microsoft Office PowerPoint</Application>
  <PresentationFormat>全屏显示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TimesNewRomanPSM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ang liyu</dc:creator>
  <cp:lastModifiedBy>huang liyu</cp:lastModifiedBy>
  <cp:revision>6</cp:revision>
  <dcterms:created xsi:type="dcterms:W3CDTF">2019-12-13T13:06:57Z</dcterms:created>
  <dcterms:modified xsi:type="dcterms:W3CDTF">2019-12-13T23:38:59Z</dcterms:modified>
</cp:coreProperties>
</file>